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8" d="100"/>
          <a:sy n="68" d="100"/>
        </p:scale>
        <p:origin x="616" y="6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C46211A-4F7C-9741-B5F8-4300C6E5CE1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B381EF93-AC51-D87F-78E0-6E720CE0B3A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E98C52D-057C-A171-309B-DE7731C13A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ABA372-9853-462F-97A7-ACF5DF2800FE}" type="datetimeFigureOut">
              <a:rPr lang="zh-CN" altLang="en-US" smtClean="0"/>
              <a:t>2023/9/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7E75F73-6E57-C771-92EC-22781096F9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9F047BB-9DAD-CECF-9FB6-D483982867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BDE38E-BE9A-4167-8140-BB56D9887DA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104109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6600599-1167-2618-7E4E-31D8D6108BD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09E8CFB5-FD08-4D0C-43F2-11E5A794375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B12E7AD-464E-6385-F4E0-C3F5DE9AA9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ABA372-9853-462F-97A7-ACF5DF2800FE}" type="datetimeFigureOut">
              <a:rPr lang="zh-CN" altLang="en-US" smtClean="0"/>
              <a:t>2023/9/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E8B4CF0-B11E-C0DA-E3BC-B780803651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33A74FE-F56A-393F-9567-8674FEA237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BDE38E-BE9A-4167-8140-BB56D9887DA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146624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FE84B0F2-B9C1-C932-659C-C2952ABE41A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0DC25C83-2BBE-E865-E1DF-6059CFDD625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B11274D-534C-CF5B-80FB-57E0C2FAB8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ABA372-9853-462F-97A7-ACF5DF2800FE}" type="datetimeFigureOut">
              <a:rPr lang="zh-CN" altLang="en-US" smtClean="0"/>
              <a:t>2023/9/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BBC1398-8582-547D-FB6D-7A1DE8DF8C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575C5F5-DC7F-7C94-B7A8-CF157EBDDE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BDE38E-BE9A-4167-8140-BB56D9887DA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741293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79799F5-D275-A8C4-5958-65A4043A120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40960DAC-FA68-9369-3E8F-328E2AF579C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EEB0507-0601-03F9-BF4A-A791BCBBA6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ABA372-9853-462F-97A7-ACF5DF2800FE}" type="datetimeFigureOut">
              <a:rPr lang="zh-CN" altLang="en-US" smtClean="0"/>
              <a:t>2023/9/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05D9BF3-6C12-BF9F-B940-CFE532C409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5C55308-729B-591F-205A-49C5BEE8A1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BDE38E-BE9A-4167-8140-BB56D9887DA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249610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C0D8326-E737-17B6-B225-548C545E729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3B95EB06-0190-593C-D23D-C62599DCFA1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9313FB6-7850-297B-E0B3-5D8938ACE4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ABA372-9853-462F-97A7-ACF5DF2800FE}" type="datetimeFigureOut">
              <a:rPr lang="zh-CN" altLang="en-US" smtClean="0"/>
              <a:t>2023/9/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D200633-A2EA-33C3-2E60-7E7599165F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8034ED2-5C30-3E92-5BB4-4352C7A767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BDE38E-BE9A-4167-8140-BB56D9887DA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951100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E809F07-15D1-69FF-BADF-5CA4C4EFBF4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91FCA23B-63BB-2DE2-4119-14EED535272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CFBD2AA1-8DFD-B1DA-797F-639630B00C9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CC68DC48-4144-A963-AC60-B95AC2D8EA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ABA372-9853-462F-97A7-ACF5DF2800FE}" type="datetimeFigureOut">
              <a:rPr lang="zh-CN" altLang="en-US" smtClean="0"/>
              <a:t>2023/9/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E66A1C5B-60C7-DFEA-DECC-126D11E5AE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87D55059-6133-98F5-C39C-9BB3E05585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BDE38E-BE9A-4167-8140-BB56D9887DA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167151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91005A2-44BE-C22E-15DF-4C3EEF52696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44E40150-6537-738D-4B77-847FA2BC334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92E41E0B-9DF0-F574-6438-D583A8ECBD0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48AD15D7-4C98-81F3-CB1A-1947FDB35AD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89643FC4-CD9F-124C-D99A-E9F152F934C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B8CD86D8-5956-A05E-5737-10D3234091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ABA372-9853-462F-97A7-ACF5DF2800FE}" type="datetimeFigureOut">
              <a:rPr lang="zh-CN" altLang="en-US" smtClean="0"/>
              <a:t>2023/9/2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6D64AC46-A790-29AB-B237-97D3EB32FE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0E3625DD-FA65-25CD-E83E-E4C98C566A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BDE38E-BE9A-4167-8140-BB56D9887DA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140124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295A084-BA29-6F10-8C59-90203A0A105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EBDD686A-4B7E-C4D0-E764-EAFAC81C7A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ABA372-9853-462F-97A7-ACF5DF2800FE}" type="datetimeFigureOut">
              <a:rPr lang="zh-CN" altLang="en-US" smtClean="0"/>
              <a:t>2023/9/2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42C9339F-0031-4DF2-1866-7DD087635E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40779392-1D2B-8B75-70E1-0EC8AD414C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BDE38E-BE9A-4167-8140-BB56D9887DA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362016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E76DDCBE-C5A2-0AB3-140A-790581005D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ABA372-9853-462F-97A7-ACF5DF2800FE}" type="datetimeFigureOut">
              <a:rPr lang="zh-CN" altLang="en-US" smtClean="0"/>
              <a:t>2023/9/2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EA822C2E-7258-44F6-55A6-4DF1D3B975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412320CB-7674-EA8E-88EA-2E8EDD4431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BDE38E-BE9A-4167-8140-BB56D9887DA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65067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37E9652-5B42-EB02-004D-E62CD1D87B5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0EB8D554-9B55-FD4D-94B3-61C3009CAA8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DF0B5C3D-8C60-B8FE-8212-D8B7AC2F3DB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55F2890D-2756-E1B3-542E-7FFD4DEA74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ABA372-9853-462F-97A7-ACF5DF2800FE}" type="datetimeFigureOut">
              <a:rPr lang="zh-CN" altLang="en-US" smtClean="0"/>
              <a:t>2023/9/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FC8EE334-93EA-DC63-1208-4934EC9041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FB718380-4E2E-1AE3-18FE-2241BBE9F0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BDE38E-BE9A-4167-8140-BB56D9887DA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576627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1D41EBF-FA4C-8B94-1663-AD51E211FA4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2F77BE3F-CB7C-83FB-E560-F871C3A50DB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971251ED-1F6C-7637-7AF2-958E78748F0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99FD6624-D097-EC4C-4C57-F701F8A858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ABA372-9853-462F-97A7-ACF5DF2800FE}" type="datetimeFigureOut">
              <a:rPr lang="zh-CN" altLang="en-US" smtClean="0"/>
              <a:t>2023/9/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1616511F-F0E3-0F74-4A12-11713E4D73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ABE29E36-BC11-218E-047F-5875B07DB8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BDE38E-BE9A-4167-8140-BB56D9887DA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312964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077F8417-D51D-74D0-6926-71490EB6B3C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AAB5BA0F-CBF2-EAE7-E591-689CCBD4937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681CE8E-6945-2F89-71B2-EF80DD4398B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ABA372-9853-462F-97A7-ACF5DF2800FE}" type="datetimeFigureOut">
              <a:rPr lang="zh-CN" altLang="en-US" smtClean="0"/>
              <a:t>2023/9/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1807541-6169-305B-2D49-7F1B1B96820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DF6F273-2CB4-79D9-1D4B-75A8BD889DF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BDE38E-BE9A-4167-8140-BB56D9887DA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499151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图片 9">
            <a:extLst>
              <a:ext uri="{FF2B5EF4-FFF2-40B4-BE49-F238E27FC236}">
                <a16:creationId xmlns:a16="http://schemas.microsoft.com/office/drawing/2014/main" id="{4C494D16-BEAA-FA04-A8AF-2A9F858F71F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25449" y="300409"/>
            <a:ext cx="9714408" cy="4658422"/>
          </a:xfrm>
          <a:prstGeom prst="rect">
            <a:avLst/>
          </a:prstGeom>
        </p:spPr>
      </p:pic>
      <p:sp>
        <p:nvSpPr>
          <p:cNvPr id="2" name="文本框 1">
            <a:extLst>
              <a:ext uri="{FF2B5EF4-FFF2-40B4-BE49-F238E27FC236}">
                <a16:creationId xmlns:a16="http://schemas.microsoft.com/office/drawing/2014/main" id="{881020CF-7E9A-B8F6-21CE-0E468929D8A2}"/>
              </a:ext>
            </a:extLst>
          </p:cNvPr>
          <p:cNvSpPr txBox="1"/>
          <p:nvPr/>
        </p:nvSpPr>
        <p:spPr>
          <a:xfrm>
            <a:off x="362199" y="4862665"/>
            <a:ext cx="11040907" cy="14465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16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igure 1.</a:t>
            </a:r>
            <a:r>
              <a:rPr lang="en-US" altLang="zh-CN" sz="16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6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Laboratory indicators were compared between patients with EBV-HLH and those with EBV-IM</a:t>
            </a:r>
            <a:r>
              <a:rPr lang="en-US" altLang="zh-CN" sz="16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in three age groups. (</a:t>
            </a:r>
            <a:r>
              <a:rPr lang="en-US" altLang="zh-CN" sz="16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  <a:sym typeface="Wingdings 2" panose="05020102010507070707" pitchFamily="18" charset="2"/>
              </a:rPr>
              <a:t></a:t>
            </a:r>
            <a:r>
              <a:rPr lang="en-US" altLang="zh-CN" sz="16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P&lt;0.05, </a:t>
            </a:r>
            <a:r>
              <a:rPr lang="en-US" altLang="zh-CN" sz="16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  <a:sym typeface="Wingdings 2" panose="05020102010507070707" pitchFamily="18" charset="2"/>
              </a:rPr>
              <a:t></a:t>
            </a:r>
            <a:r>
              <a:rPr lang="en-US" altLang="zh-CN" sz="16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P&lt;0.01, </a:t>
            </a:r>
            <a:r>
              <a:rPr lang="en-US" altLang="zh-CN" sz="16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  <a:sym typeface="Wingdings 2" panose="05020102010507070707" pitchFamily="18" charset="2"/>
              </a:rPr>
              <a:t></a:t>
            </a:r>
            <a:r>
              <a:rPr lang="en-US" altLang="zh-CN" sz="16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P&lt;0.001, </a:t>
            </a:r>
            <a:r>
              <a:rPr lang="en-US" altLang="zh-CN" sz="16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  <a:sym typeface="Wingdings 2" panose="05020102010507070707" pitchFamily="18" charset="2"/>
              </a:rPr>
              <a:t> </a:t>
            </a:r>
            <a:r>
              <a:rPr lang="en-US" altLang="zh-CN" sz="16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P&lt;0.0001) </a:t>
            </a:r>
            <a:r>
              <a:rPr lang="en-US" altLang="zh-CN" sz="16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A,CD4+% B,CD8+% C,CD4+/CD8+ D,IL-6  E,IL-10 F, IFN-γ G,LDH, lactate dehydrogenase  H,D-dimer</a:t>
            </a:r>
            <a:endParaRPr lang="zh-CN" altLang="zh-CN" sz="1600" kern="100" dirty="0">
              <a:effectLst/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7669385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6</TotalTime>
  <Words>73</Words>
  <Application>Microsoft Office PowerPoint</Application>
  <PresentationFormat>宽屏</PresentationFormat>
  <Paragraphs>1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等线 Light</vt:lpstr>
      <vt:lpstr>Arial</vt:lpstr>
      <vt:lpstr>Times New Roman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蔡 丽莎</dc:creator>
  <cp:lastModifiedBy>蔡 丽莎</cp:lastModifiedBy>
  <cp:revision>4</cp:revision>
  <dcterms:created xsi:type="dcterms:W3CDTF">2023-08-29T03:37:14Z</dcterms:created>
  <dcterms:modified xsi:type="dcterms:W3CDTF">2023-09-02T10:11:53Z</dcterms:modified>
</cp:coreProperties>
</file>